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modernComment_101_3B249DE5.xml" ContentType="application/vnd.ms-powerpoint.comment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906000" type="A4"/>
  <p:notesSz cx="6669088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4" roundtripDataSignature="AMtx7midPRuFTzd7175hgEXLH8/FnCpbM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2A6B768-FD5F-7E08-29BA-645110A844E6}" name="Wong, Stephen Q." initials="SW" userId="S::swong@houstonmethodist.org::2a8ec965-c961-44eb-8898-f2952af7cd62" providerId="AD"/>
  <p188:author id="{FBBDEF89-E001-42E6-A122-65C359D21E47}" name="dasmohua1991@gmail.com" initials="d" userId="c47b03fee764e2f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A4FF6B"/>
    <a:srgbClr val="0432FF"/>
    <a:srgbClr val="A67728"/>
    <a:srgbClr val="00C700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0DF16DD-CEAE-429F-B386-2EFEC26C250D}">
  <a:tblStyle styleId="{F0DF16DD-CEAE-429F-B386-2EFEC26C250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 b="off" i="off"/>
      <a:tcStyle>
        <a:tcBdr/>
        <a:fill>
          <a:solidFill>
            <a:srgbClr val="E6E6E6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6E6E6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eCell>
    <a:sw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13351516-2F73-430D-880C-78F66EE1126C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972"/>
    <p:restoredTop sz="94855"/>
  </p:normalViewPr>
  <p:slideViewPr>
    <p:cSldViewPr snapToGrid="0">
      <p:cViewPr>
        <p:scale>
          <a:sx n="141" d="100"/>
          <a:sy n="141" d="100"/>
        </p:scale>
        <p:origin x="1064" y="-3656"/>
      </p:cViewPr>
      <p:guideLst>
        <p:guide orient="horz" pos="3143"/>
        <p:guide pos="2160"/>
      </p:guideLst>
    </p:cSldViewPr>
  </p:slideViewPr>
  <p:notesTextViewPr>
    <p:cViewPr>
      <p:scale>
        <a:sx n="170" d="100"/>
        <a:sy n="1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presProps" Target="presProps.xml"/><Relationship Id="rId49" Type="http://schemas.microsoft.com/office/2018/10/relationships/authors" Target="authors.xml"/><Relationship Id="rId44" Type="http://customschemas.google.com/relationships/presentationmetadata" Target="metadata"/><Relationship Id="rId4" Type="http://schemas.openxmlformats.org/officeDocument/2006/relationships/notesMaster" Target="notesMasters/notesMaster1.xml"/><Relationship Id="rId48" Type="http://schemas.openxmlformats.org/officeDocument/2006/relationships/tableStyles" Target="tableStyles.xml"/></Relationships>
</file>

<file path=ppt/comments/modernComment_101_3B249DE5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C2BDBD0A-CACE-FE43-B386-DC50DB91FD8B}" authorId="{FBBDEF89-E001-42E6-A122-65C359D21E47}" status="resolved" created="2025-04-07T21:34:58.362" complete="100000">
    <pc:sldMkLst xmlns:pc="http://schemas.microsoft.com/office/powerpoint/2013/main/command">
      <pc:docMk/>
      <pc:sldMk cId="992255461" sldId="257"/>
    </pc:sldMkLst>
    <p188:replyLst>
      <p188:reply id="{B0C57358-CDD2-2F47-9114-2281EE8D2BEF}" authorId="{72A6B768-FD5F-7E08-29BA-645110A844E6}" created="2025-04-08T02:15:52.001">
        <p188:txBody>
          <a:bodyPr/>
          <a:lstStyle/>
          <a:p>
            <a:r>
              <a:rPr lang="en-US"/>
              <a:t>That’s why there is still a % nodule area. We didn’t say there are no nodules</a:t>
            </a:r>
          </a:p>
        </p188:txBody>
      </p188:reply>
    </p188:replyLst>
    <p188:txBody>
      <a:bodyPr/>
      <a:lstStyle/>
      <a:p>
        <a:r>
          <a:rPr lang="en-US"/>
          <a:t>SW480 also seems to have nodules, just smaller in size. Can we mention the size cut-off used for nodule calculation?</a:t>
        </a:r>
      </a:p>
    </p188:txBody>
  </p188:cm>
</p188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777607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7" name="Google Shape;137;p2:notes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 b="1" dirty="0"/>
              <a:t>Refer to word document</a:t>
            </a:r>
            <a:endParaRPr b="0" i="0" dirty="0"/>
          </a:p>
        </p:txBody>
      </p:sp>
      <p:sp>
        <p:nvSpPr>
          <p:cNvPr id="138" name="Google Shape;138;p2:notes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1396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8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5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6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6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8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8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emf"/><Relationship Id="rId3" Type="http://schemas.microsoft.com/office/2018/10/relationships/comments" Target="../comments/modernComment_101_3B249DE5.xml"/><Relationship Id="rId7" Type="http://schemas.openxmlformats.org/officeDocument/2006/relationships/image" Target="../media/image4.png"/><Relationship Id="rId12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8.emf"/><Relationship Id="rId5" Type="http://schemas.openxmlformats.org/officeDocument/2006/relationships/image" Target="../media/image2.png"/><Relationship Id="rId15" Type="http://schemas.openxmlformats.org/officeDocument/2006/relationships/image" Target="../media/image12.emf"/><Relationship Id="rId10" Type="http://schemas.openxmlformats.org/officeDocument/2006/relationships/image" Target="../media/image7.png"/><Relationship Id="rId4" Type="http://schemas.openxmlformats.org/officeDocument/2006/relationships/image" Target="../media/image1.png"/><Relationship Id="rId9" Type="http://schemas.openxmlformats.org/officeDocument/2006/relationships/image" Target="../media/image6.png"/><Relationship Id="rId14" Type="http://schemas.openxmlformats.org/officeDocument/2006/relationships/image" Target="../media/image1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Google Shape;141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883477" y="579300"/>
            <a:ext cx="2953229" cy="1527439"/>
          </a:xfrm>
          <a:prstGeom prst="rect">
            <a:avLst/>
          </a:prstGeom>
          <a:noFill/>
          <a:ln>
            <a:noFill/>
          </a:ln>
        </p:spPr>
      </p:pic>
      <p:sp>
        <p:nvSpPr>
          <p:cNvPr id="142" name="Google Shape;142;p2"/>
          <p:cNvSpPr txBox="1"/>
          <p:nvPr/>
        </p:nvSpPr>
        <p:spPr>
          <a:xfrm>
            <a:off x="-14561" y="355723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3" name="Google Shape;143;p2"/>
          <p:cNvSpPr txBox="1"/>
          <p:nvPr/>
        </p:nvSpPr>
        <p:spPr>
          <a:xfrm>
            <a:off x="1872355" y="355723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4" name="Google Shape;144;p2"/>
          <p:cNvSpPr txBox="1"/>
          <p:nvPr/>
        </p:nvSpPr>
        <p:spPr>
          <a:xfrm>
            <a:off x="3801871" y="355723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C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5" name="Google Shape;145;p2"/>
          <p:cNvSpPr txBox="1"/>
          <p:nvPr/>
        </p:nvSpPr>
        <p:spPr>
          <a:xfrm>
            <a:off x="-14561" y="2327166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D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6" name="Google Shape;146;p2"/>
          <p:cNvSpPr txBox="1"/>
          <p:nvPr/>
        </p:nvSpPr>
        <p:spPr>
          <a:xfrm>
            <a:off x="3645244" y="3949263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J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7" name="Google Shape;147;p2"/>
          <p:cNvSpPr txBox="1"/>
          <p:nvPr/>
        </p:nvSpPr>
        <p:spPr>
          <a:xfrm>
            <a:off x="1587794" y="2327166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E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8" name="Google Shape;148;p2"/>
          <p:cNvSpPr txBox="1"/>
          <p:nvPr/>
        </p:nvSpPr>
        <p:spPr>
          <a:xfrm>
            <a:off x="3205620" y="2327166"/>
            <a:ext cx="26161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F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9" name="Google Shape;149;p2"/>
          <p:cNvSpPr txBox="1"/>
          <p:nvPr/>
        </p:nvSpPr>
        <p:spPr>
          <a:xfrm>
            <a:off x="4935313" y="2327166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G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50" name="Google Shape;150;p2"/>
          <p:cNvSpPr txBox="1"/>
          <p:nvPr/>
        </p:nvSpPr>
        <p:spPr>
          <a:xfrm>
            <a:off x="-14561" y="3949263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H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54" name="Google Shape;154;p2"/>
          <p:cNvSpPr txBox="1"/>
          <p:nvPr/>
        </p:nvSpPr>
        <p:spPr>
          <a:xfrm>
            <a:off x="-14561" y="5984754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K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55" name="Google Shape;155;p2"/>
          <p:cNvSpPr txBox="1"/>
          <p:nvPr/>
        </p:nvSpPr>
        <p:spPr>
          <a:xfrm>
            <a:off x="1670156" y="3949263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I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56" name="Google Shape;156;p2"/>
          <p:cNvSpPr txBox="1"/>
          <p:nvPr/>
        </p:nvSpPr>
        <p:spPr>
          <a:xfrm>
            <a:off x="2373339" y="5984754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L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pic>
        <p:nvPicPr>
          <p:cNvPr id="157" name="Google Shape;157;p2"/>
          <p:cNvPicPr preferRelativeResize="0">
            <a:picLocks noChangeAspect="1"/>
          </p:cNvPicPr>
          <p:nvPr/>
        </p:nvPicPr>
        <p:blipFill rotWithShape="1">
          <a:blip r:embed="rId5">
            <a:alphaModFix/>
          </a:blip>
          <a:srcRect l="9184" r="10712"/>
          <a:stretch/>
        </p:blipFill>
        <p:spPr>
          <a:xfrm>
            <a:off x="3610363" y="2582123"/>
            <a:ext cx="1248442" cy="12959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60" name="Google Shape;160;p2"/>
          <p:cNvPicPr preferRelativeResize="0"/>
          <p:nvPr/>
        </p:nvPicPr>
        <p:blipFill rotWithShape="1">
          <a:blip r:embed="rId6">
            <a:alphaModFix/>
          </a:blip>
          <a:srcRect l="6845" t="50066"/>
          <a:stretch/>
        </p:blipFill>
        <p:spPr>
          <a:xfrm>
            <a:off x="2885440" y="6465053"/>
            <a:ext cx="2688608" cy="914661"/>
          </a:xfrm>
          <a:prstGeom prst="rect">
            <a:avLst/>
          </a:prstGeom>
          <a:noFill/>
          <a:ln>
            <a:noFill/>
          </a:ln>
        </p:spPr>
      </p:pic>
      <p:pic>
        <p:nvPicPr>
          <p:cNvPr id="162" name="Google Shape;162;p2"/>
          <p:cNvPicPr preferRelativeResize="0"/>
          <p:nvPr/>
        </p:nvPicPr>
        <p:blipFill rotWithShape="1">
          <a:blip r:embed="rId7">
            <a:alphaModFix/>
          </a:blip>
          <a:srcRect l="10516" t="11946" b="10288"/>
          <a:stretch/>
        </p:blipFill>
        <p:spPr>
          <a:xfrm>
            <a:off x="312906" y="686183"/>
            <a:ext cx="1626336" cy="1394751"/>
          </a:xfrm>
          <a:prstGeom prst="rect">
            <a:avLst/>
          </a:prstGeom>
          <a:noFill/>
          <a:ln>
            <a:noFill/>
          </a:ln>
        </p:spPr>
      </p:pic>
      <p:sp>
        <p:nvSpPr>
          <p:cNvPr id="165" name="Google Shape;165;p2"/>
          <p:cNvSpPr txBox="1"/>
          <p:nvPr/>
        </p:nvSpPr>
        <p:spPr>
          <a:xfrm>
            <a:off x="451167" y="2363359"/>
            <a:ext cx="1387187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-Invasion</a:t>
            </a:r>
            <a:endParaRPr sz="105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66" name="Google Shape;166;p2"/>
          <p:cNvSpPr txBox="1"/>
          <p:nvPr/>
        </p:nvSpPr>
        <p:spPr>
          <a:xfrm>
            <a:off x="1941264" y="2382343"/>
            <a:ext cx="1314859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-Migration</a:t>
            </a:r>
            <a:endParaRPr sz="105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A660158-6906-5543-6C34-086AD5AEAAF3}"/>
              </a:ext>
            </a:extLst>
          </p:cNvPr>
          <p:cNvGrpSpPr/>
          <p:nvPr/>
        </p:nvGrpSpPr>
        <p:grpSpPr>
          <a:xfrm>
            <a:off x="-284892" y="6322978"/>
            <a:ext cx="2475233" cy="1298805"/>
            <a:chOff x="3625571" y="3908720"/>
            <a:chExt cx="2475233" cy="1298805"/>
          </a:xfrm>
        </p:grpSpPr>
        <p:pic>
          <p:nvPicPr>
            <p:cNvPr id="159" name="Google Shape;159;p2"/>
            <p:cNvPicPr preferRelativeResize="0"/>
            <p:nvPr/>
          </p:nvPicPr>
          <p:blipFill rotWithShape="1">
            <a:blip r:embed="rId8">
              <a:alphaModFix/>
            </a:blip>
            <a:srcRect l="56016" t="17557" r="1854" b="5451"/>
            <a:stretch/>
          </p:blipFill>
          <p:spPr>
            <a:xfrm>
              <a:off x="4555585" y="3908720"/>
              <a:ext cx="1545219" cy="129880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7" name="Google Shape;167;p2"/>
            <p:cNvSpPr txBox="1"/>
            <p:nvPr/>
          </p:nvSpPr>
          <p:spPr>
            <a:xfrm>
              <a:off x="3625571" y="4072081"/>
              <a:ext cx="997359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8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W480-PAR</a:t>
              </a:r>
              <a:endParaRPr sz="90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68" name="Google Shape;168;p2"/>
            <p:cNvSpPr txBox="1"/>
            <p:nvPr/>
          </p:nvSpPr>
          <p:spPr>
            <a:xfrm>
              <a:off x="3867594" y="4337789"/>
              <a:ext cx="755336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8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W480-LD</a:t>
              </a:r>
              <a:endParaRPr sz="105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69" name="Google Shape;169;p2"/>
            <p:cNvSpPr txBox="1"/>
            <p:nvPr/>
          </p:nvSpPr>
          <p:spPr>
            <a:xfrm>
              <a:off x="3808283" y="4623828"/>
              <a:ext cx="814647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8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W480-MD</a:t>
              </a:r>
              <a:endParaRPr sz="105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70" name="Google Shape;170;p2"/>
            <p:cNvSpPr txBox="1"/>
            <p:nvPr/>
          </p:nvSpPr>
          <p:spPr>
            <a:xfrm>
              <a:off x="3840343" y="4859310"/>
              <a:ext cx="782587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800" b="1" i="0" u="none" strike="noStrike" cap="none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W480-HD</a:t>
              </a:r>
              <a:endParaRPr sz="1050" b="0" i="0" u="none" strike="noStrike" cap="none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F4ACCA4C-B3BC-1920-71D4-7AAFC731A29E}"/>
              </a:ext>
            </a:extLst>
          </p:cNvPr>
          <p:cNvGrpSpPr/>
          <p:nvPr/>
        </p:nvGrpSpPr>
        <p:grpSpPr>
          <a:xfrm>
            <a:off x="1821214" y="4071886"/>
            <a:ext cx="1836909" cy="1738486"/>
            <a:chOff x="116907" y="3689750"/>
            <a:chExt cx="1836909" cy="1738486"/>
          </a:xfrm>
        </p:grpSpPr>
        <p:pic>
          <p:nvPicPr>
            <p:cNvPr id="151" name="Google Shape;151;p2"/>
            <p:cNvPicPr preferRelativeResize="0"/>
            <p:nvPr/>
          </p:nvPicPr>
          <p:blipFill rotWithShape="1">
            <a:blip r:embed="rId9">
              <a:alphaModFix/>
            </a:blip>
            <a:srcRect/>
            <a:stretch/>
          </p:blipFill>
          <p:spPr>
            <a:xfrm>
              <a:off x="116907" y="3767775"/>
              <a:ext cx="1836909" cy="166046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1" name="Google Shape;171;p2"/>
            <p:cNvSpPr txBox="1"/>
            <p:nvPr/>
          </p:nvSpPr>
          <p:spPr>
            <a:xfrm>
              <a:off x="791923" y="3689750"/>
              <a:ext cx="729842" cy="2461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1000" b="1" i="0" u="none" strike="noStrike" cap="none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SW480</a:t>
              </a:r>
              <a:endParaRPr sz="1050" b="0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pic>
        <p:nvPicPr>
          <p:cNvPr id="173" name="Google Shape;173;p2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105615" y="4197168"/>
            <a:ext cx="1751477" cy="158329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171;p2">
            <a:extLst>
              <a:ext uri="{FF2B5EF4-FFF2-40B4-BE49-F238E27FC236}">
                <a16:creationId xmlns:a16="http://schemas.microsoft.com/office/drawing/2014/main" id="{B6A01DA9-4977-3395-CF66-788F7A4C07EA}"/>
              </a:ext>
            </a:extLst>
          </p:cNvPr>
          <p:cNvSpPr txBox="1"/>
          <p:nvPr/>
        </p:nvSpPr>
        <p:spPr>
          <a:xfrm>
            <a:off x="763550" y="4037926"/>
            <a:ext cx="77030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HCT116</a:t>
            </a:r>
            <a:endParaRPr sz="14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6" name="Google Shape;156;p2">
            <a:extLst>
              <a:ext uri="{FF2B5EF4-FFF2-40B4-BE49-F238E27FC236}">
                <a16:creationId xmlns:a16="http://schemas.microsoft.com/office/drawing/2014/main" id="{99B58938-45A2-9001-06FB-B6C2FAC4958E}"/>
              </a:ext>
            </a:extLst>
          </p:cNvPr>
          <p:cNvSpPr txBox="1"/>
          <p:nvPr/>
        </p:nvSpPr>
        <p:spPr>
          <a:xfrm>
            <a:off x="-14561" y="7893298"/>
            <a:ext cx="2487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M</a:t>
            </a:r>
            <a:endParaRPr sz="1800" b="1" i="0" u="none" strike="noStrike" cap="none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8" name="Google Shape;116;p1">
            <a:extLst>
              <a:ext uri="{FF2B5EF4-FFF2-40B4-BE49-F238E27FC236}">
                <a16:creationId xmlns:a16="http://schemas.microsoft.com/office/drawing/2014/main" id="{4F23C48F-CDD5-B9AC-F859-F6950412F6BB}"/>
              </a:ext>
            </a:extLst>
          </p:cNvPr>
          <p:cNvSpPr txBox="1"/>
          <p:nvPr/>
        </p:nvSpPr>
        <p:spPr>
          <a:xfrm rot="-5400000">
            <a:off x="-352935" y="1212878"/>
            <a:ext cx="1196138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% viability (+/- </a:t>
            </a:r>
            <a:r>
              <a:rPr lang="en-US" sz="800" b="1" i="0" u="none" strike="noStrike" cap="none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.d.</a:t>
            </a: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)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0" name="Google Shape;113;p1">
            <a:extLst>
              <a:ext uri="{FF2B5EF4-FFF2-40B4-BE49-F238E27FC236}">
                <a16:creationId xmlns:a16="http://schemas.microsoft.com/office/drawing/2014/main" id="{0039E6D7-1F0B-AC31-7ECF-74235508AE6E}"/>
              </a:ext>
            </a:extLst>
          </p:cNvPr>
          <p:cNvSpPr txBox="1"/>
          <p:nvPr/>
        </p:nvSpPr>
        <p:spPr>
          <a:xfrm>
            <a:off x="2204146" y="440002"/>
            <a:ext cx="163538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W480 Dose Response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4" name="Google Shape;122;p1">
            <a:extLst>
              <a:ext uri="{FF2B5EF4-FFF2-40B4-BE49-F238E27FC236}">
                <a16:creationId xmlns:a16="http://schemas.microsoft.com/office/drawing/2014/main" id="{E3D160ED-A7D8-725B-1FCE-B2B643F28E9E}"/>
              </a:ext>
            </a:extLst>
          </p:cNvPr>
          <p:cNvSpPr txBox="1"/>
          <p:nvPr/>
        </p:nvSpPr>
        <p:spPr>
          <a:xfrm rot="-5400000">
            <a:off x="1231384" y="3097457"/>
            <a:ext cx="1148071" cy="20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7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% Migration</a:t>
            </a:r>
            <a:endParaRPr sz="14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5" name="Google Shape;120;p1">
            <a:extLst>
              <a:ext uri="{FF2B5EF4-FFF2-40B4-BE49-F238E27FC236}">
                <a16:creationId xmlns:a16="http://schemas.microsoft.com/office/drawing/2014/main" id="{29F54F1A-BFCE-1D2E-A79B-800B83C948A4}"/>
              </a:ext>
            </a:extLst>
          </p:cNvPr>
          <p:cNvSpPr txBox="1"/>
          <p:nvPr/>
        </p:nvSpPr>
        <p:spPr>
          <a:xfrm rot="-5400000">
            <a:off x="-310219" y="3085485"/>
            <a:ext cx="1162498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% Invasion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7" name="Google Shape;133;p1">
            <a:extLst>
              <a:ext uri="{FF2B5EF4-FFF2-40B4-BE49-F238E27FC236}">
                <a16:creationId xmlns:a16="http://schemas.microsoft.com/office/drawing/2014/main" id="{A07AA4B8-1F60-69C2-A6FB-2B15DEAA534F}"/>
              </a:ext>
            </a:extLst>
          </p:cNvPr>
          <p:cNvSpPr txBox="1"/>
          <p:nvPr/>
        </p:nvSpPr>
        <p:spPr>
          <a:xfrm rot="-5400000">
            <a:off x="3209557" y="4847150"/>
            <a:ext cx="153546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Tumor volume (mm</a:t>
            </a:r>
            <a:r>
              <a:rPr lang="en-US" sz="800" b="1" i="0" u="none" strike="noStrike" cap="none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3</a:t>
            </a: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)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EBA8B7E-D8D3-78F1-FD1C-B74962BAB65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48024" y="2615045"/>
            <a:ext cx="1207512" cy="129907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CD9B3ED-46CC-C588-864C-687745B5CDD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9625" y="2575422"/>
            <a:ext cx="1233406" cy="135257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B96AFCF-175E-B195-5816-9766AAC3A34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07150" y="642522"/>
            <a:ext cx="1314859" cy="150269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D5423F1-4504-9829-035D-F3190C8656E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557870" y="2482513"/>
            <a:ext cx="1262608" cy="138531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2977850-859B-8A60-DAD2-7A1FF4B99354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b="9182"/>
          <a:stretch/>
        </p:blipFill>
        <p:spPr>
          <a:xfrm>
            <a:off x="4077295" y="4159405"/>
            <a:ext cx="1709241" cy="153546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C803A2B-591B-76C0-04B2-CBC5CD20EC2D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b="21057"/>
          <a:stretch/>
        </p:blipFill>
        <p:spPr>
          <a:xfrm>
            <a:off x="777116" y="7717129"/>
            <a:ext cx="1177821" cy="1527539"/>
          </a:xfrm>
          <a:prstGeom prst="rect">
            <a:avLst/>
          </a:prstGeom>
        </p:spPr>
      </p:pic>
      <p:pic>
        <p:nvPicPr>
          <p:cNvPr id="26" name="Google Shape;160;p2">
            <a:extLst>
              <a:ext uri="{FF2B5EF4-FFF2-40B4-BE49-F238E27FC236}">
                <a16:creationId xmlns:a16="http://schemas.microsoft.com/office/drawing/2014/main" id="{89B8EAF6-648D-1148-BA86-480AADB9F075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 l="7127" b="50066"/>
          <a:stretch/>
        </p:blipFill>
        <p:spPr>
          <a:xfrm>
            <a:off x="2893568" y="7341835"/>
            <a:ext cx="2680480" cy="91466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Google Shape;114;p1">
            <a:extLst>
              <a:ext uri="{FF2B5EF4-FFF2-40B4-BE49-F238E27FC236}">
                <a16:creationId xmlns:a16="http://schemas.microsoft.com/office/drawing/2014/main" id="{3F55641C-1993-7A58-383A-00701D555F98}"/>
              </a:ext>
            </a:extLst>
          </p:cNvPr>
          <p:cNvSpPr txBox="1"/>
          <p:nvPr/>
        </p:nvSpPr>
        <p:spPr>
          <a:xfrm rot="-5400000">
            <a:off x="1484333" y="1177425"/>
            <a:ext cx="1335760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IC</a:t>
            </a:r>
            <a:r>
              <a:rPr lang="en-US" sz="800" b="1" i="0" u="none" strike="noStrike" cap="none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50 </a:t>
            </a: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Fold Change relative to PAR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7" name="Google Shape;166;p2">
            <a:extLst>
              <a:ext uri="{FF2B5EF4-FFF2-40B4-BE49-F238E27FC236}">
                <a16:creationId xmlns:a16="http://schemas.microsoft.com/office/drawing/2014/main" id="{39A02993-F32C-E78E-978A-E2595063954B}"/>
              </a:ext>
            </a:extLst>
          </p:cNvPr>
          <p:cNvSpPr txBox="1"/>
          <p:nvPr/>
        </p:nvSpPr>
        <p:spPr>
          <a:xfrm>
            <a:off x="3910623" y="2384370"/>
            <a:ext cx="68937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</a:t>
            </a:r>
            <a:endParaRPr sz="105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9" name="Google Shape;131;p1">
            <a:extLst>
              <a:ext uri="{FF2B5EF4-FFF2-40B4-BE49-F238E27FC236}">
                <a16:creationId xmlns:a16="http://schemas.microsoft.com/office/drawing/2014/main" id="{9BA82C3C-9FDC-3762-FFD2-60159C8F6CFB}"/>
              </a:ext>
            </a:extLst>
          </p:cNvPr>
          <p:cNvSpPr txBox="1"/>
          <p:nvPr/>
        </p:nvSpPr>
        <p:spPr>
          <a:xfrm rot="-5400000">
            <a:off x="4608831" y="2983868"/>
            <a:ext cx="1549744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% Nodule / total lung area (+/- </a:t>
            </a:r>
            <a:r>
              <a:rPr lang="en-US" sz="800" b="1" i="0" u="none" strike="noStrike" cap="none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.e.m.</a:t>
            </a: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)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1" name="Google Shape;166;p2">
            <a:extLst>
              <a:ext uri="{FF2B5EF4-FFF2-40B4-BE49-F238E27FC236}">
                <a16:creationId xmlns:a16="http://schemas.microsoft.com/office/drawing/2014/main" id="{ED4E76EC-AF2D-C605-F19D-BFD4BE672DEA}"/>
              </a:ext>
            </a:extLst>
          </p:cNvPr>
          <p:cNvSpPr txBox="1"/>
          <p:nvPr/>
        </p:nvSpPr>
        <p:spPr>
          <a:xfrm>
            <a:off x="5874250" y="2348372"/>
            <a:ext cx="68937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</a:t>
            </a:r>
            <a:endParaRPr sz="105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2" name="Google Shape;166;p2">
            <a:extLst>
              <a:ext uri="{FF2B5EF4-FFF2-40B4-BE49-F238E27FC236}">
                <a16:creationId xmlns:a16="http://schemas.microsoft.com/office/drawing/2014/main" id="{DE62EF26-C877-7BC7-6174-235A826FC38B}"/>
              </a:ext>
            </a:extLst>
          </p:cNvPr>
          <p:cNvSpPr txBox="1"/>
          <p:nvPr/>
        </p:nvSpPr>
        <p:spPr>
          <a:xfrm>
            <a:off x="3845091" y="6153566"/>
            <a:ext cx="68937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</a:t>
            </a:r>
            <a:endParaRPr sz="105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3" name="Google Shape;131;p1">
            <a:extLst>
              <a:ext uri="{FF2B5EF4-FFF2-40B4-BE49-F238E27FC236}">
                <a16:creationId xmlns:a16="http://schemas.microsoft.com/office/drawing/2014/main" id="{CCAD13E6-27E2-3A36-48E5-2D7F6444AB4D}"/>
              </a:ext>
            </a:extLst>
          </p:cNvPr>
          <p:cNvSpPr txBox="1"/>
          <p:nvPr/>
        </p:nvSpPr>
        <p:spPr>
          <a:xfrm rot="-5400000">
            <a:off x="-202402" y="8313773"/>
            <a:ext cx="1549744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% Nodule / total lung area (+/- </a:t>
            </a:r>
            <a:r>
              <a:rPr lang="en-US" sz="800" b="1" i="0" u="none" strike="noStrike" cap="none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.e.m.</a:t>
            </a: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)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B383201-D4F3-1E05-70B6-2FFA08BE647E}"/>
              </a:ext>
            </a:extLst>
          </p:cNvPr>
          <p:cNvSpPr txBox="1"/>
          <p:nvPr/>
        </p:nvSpPr>
        <p:spPr>
          <a:xfrm rot="16200000">
            <a:off x="2288345" y="6811262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Vehicl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D0B142E-50A9-60FB-41F0-44120E4D6FB9}"/>
              </a:ext>
            </a:extLst>
          </p:cNvPr>
          <p:cNvSpPr txBox="1"/>
          <p:nvPr/>
        </p:nvSpPr>
        <p:spPr>
          <a:xfrm rot="16200000">
            <a:off x="2244266" y="7586147"/>
            <a:ext cx="8723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Oxaliplatin </a:t>
            </a:r>
          </a:p>
          <a:p>
            <a:pPr algn="ctr"/>
            <a:r>
              <a:rPr lang="en-US" sz="1000" b="1" dirty="0"/>
              <a:t>(5 mg/kg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337C599-6837-96BD-FAAE-A431C135F469}"/>
              </a:ext>
            </a:extLst>
          </p:cNvPr>
          <p:cNvSpPr txBox="1"/>
          <p:nvPr/>
        </p:nvSpPr>
        <p:spPr>
          <a:xfrm rot="16200000">
            <a:off x="3286458" y="2797166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PA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81EAC0F-0917-8E45-10EC-78A2DB635638}"/>
              </a:ext>
            </a:extLst>
          </p:cNvPr>
          <p:cNvSpPr txBox="1"/>
          <p:nvPr/>
        </p:nvSpPr>
        <p:spPr>
          <a:xfrm rot="16200000">
            <a:off x="3321725" y="341121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4CC7F7E-34F3-D66C-2ED0-A42AC65425D0}"/>
              </a:ext>
            </a:extLst>
          </p:cNvPr>
          <p:cNvSpPr txBox="1"/>
          <p:nvPr/>
        </p:nvSpPr>
        <p:spPr>
          <a:xfrm rot="5400000">
            <a:off x="4765979" y="282499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CC70F2D-2A41-8204-16D1-E1119C7F9486}"/>
              </a:ext>
            </a:extLst>
          </p:cNvPr>
          <p:cNvSpPr txBox="1"/>
          <p:nvPr/>
        </p:nvSpPr>
        <p:spPr>
          <a:xfrm rot="5400000">
            <a:off x="4758767" y="3439046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H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2860672-E83F-F3EB-E33A-A8F03D3BAF90}"/>
              </a:ext>
            </a:extLst>
          </p:cNvPr>
          <p:cNvSpPr txBox="1"/>
          <p:nvPr/>
        </p:nvSpPr>
        <p:spPr>
          <a:xfrm>
            <a:off x="4722563" y="559803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Da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F1EB69B-3289-7815-87B6-3AF510059901}"/>
              </a:ext>
            </a:extLst>
          </p:cNvPr>
          <p:cNvSpPr txBox="1"/>
          <p:nvPr/>
        </p:nvSpPr>
        <p:spPr>
          <a:xfrm rot="16200000">
            <a:off x="883853" y="9372749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Vehicl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C1FC0A5-B834-EFA8-7B4F-8C9C789D9B40}"/>
              </a:ext>
            </a:extLst>
          </p:cNvPr>
          <p:cNvSpPr txBox="1"/>
          <p:nvPr/>
        </p:nvSpPr>
        <p:spPr>
          <a:xfrm rot="16200000">
            <a:off x="1195746" y="9394939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b="1" dirty="0"/>
              <a:t>Oxaliplatin</a:t>
            </a:r>
          </a:p>
          <a:p>
            <a:pPr algn="r"/>
            <a:r>
              <a:rPr lang="en-US" sz="900" b="1" dirty="0"/>
              <a:t>(5 mg/kg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910312E-1822-D83C-10EC-A5A38F1DA53C}"/>
              </a:ext>
            </a:extLst>
          </p:cNvPr>
          <p:cNvSpPr txBox="1"/>
          <p:nvPr/>
        </p:nvSpPr>
        <p:spPr>
          <a:xfrm>
            <a:off x="1067106" y="7696808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W480</a:t>
            </a:r>
          </a:p>
        </p:txBody>
      </p:sp>
      <p:sp>
        <p:nvSpPr>
          <p:cNvPr id="38" name="Google Shape;166;p2">
            <a:extLst>
              <a:ext uri="{FF2B5EF4-FFF2-40B4-BE49-F238E27FC236}">
                <a16:creationId xmlns:a16="http://schemas.microsoft.com/office/drawing/2014/main" id="{20584B69-AE13-8FF1-C59A-99181B32A435}"/>
              </a:ext>
            </a:extLst>
          </p:cNvPr>
          <p:cNvSpPr txBox="1"/>
          <p:nvPr/>
        </p:nvSpPr>
        <p:spPr>
          <a:xfrm>
            <a:off x="4547649" y="4020281"/>
            <a:ext cx="68937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W480</a:t>
            </a:r>
            <a:endParaRPr sz="11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27" name="Google Shape;102;p1">
            <a:extLst>
              <a:ext uri="{FF2B5EF4-FFF2-40B4-BE49-F238E27FC236}">
                <a16:creationId xmlns:a16="http://schemas.microsoft.com/office/drawing/2014/main" id="{50B348D5-69A1-58D3-9B0D-93245D44E5E3}"/>
              </a:ext>
            </a:extLst>
          </p:cNvPr>
          <p:cNvSpPr txBox="1"/>
          <p:nvPr/>
        </p:nvSpPr>
        <p:spPr>
          <a:xfrm>
            <a:off x="255198" y="45030"/>
            <a:ext cx="639423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S1. Characterization of SW480 oxaliplatin-resistant model</a:t>
            </a:r>
          </a:p>
        </p:txBody>
      </p:sp>
      <p:sp>
        <p:nvSpPr>
          <p:cNvPr id="16" name="Google Shape;113;p1">
            <a:extLst>
              <a:ext uri="{FF2B5EF4-FFF2-40B4-BE49-F238E27FC236}">
                <a16:creationId xmlns:a16="http://schemas.microsoft.com/office/drawing/2014/main" id="{B8D9003D-353C-E8C3-B08B-2F8CA363D6D8}"/>
              </a:ext>
            </a:extLst>
          </p:cNvPr>
          <p:cNvSpPr txBox="1"/>
          <p:nvPr/>
        </p:nvSpPr>
        <p:spPr>
          <a:xfrm>
            <a:off x="347889" y="418291"/>
            <a:ext cx="163538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SW480 Dose Response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37" name="Google Shape;117;p1">
            <a:extLst>
              <a:ext uri="{FF2B5EF4-FFF2-40B4-BE49-F238E27FC236}">
                <a16:creationId xmlns:a16="http://schemas.microsoft.com/office/drawing/2014/main" id="{9580B3CE-23D0-8370-BCC8-E1DA464E7977}"/>
              </a:ext>
            </a:extLst>
          </p:cNvPr>
          <p:cNvSpPr txBox="1"/>
          <p:nvPr/>
        </p:nvSpPr>
        <p:spPr>
          <a:xfrm>
            <a:off x="623712" y="2061581"/>
            <a:ext cx="891591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800" b="1" i="0" u="none" strike="noStrike" cap="none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Log dose (µM)</a:t>
            </a:r>
            <a:endParaRPr sz="16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92255461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3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5BADF24-EEDD-5128-D680-7AF2B0D552B7}"/>
              </a:ext>
            </a:extLst>
          </p:cNvPr>
          <p:cNvSpPr txBox="1"/>
          <p:nvPr/>
        </p:nvSpPr>
        <p:spPr>
          <a:xfrm>
            <a:off x="2367643" y="1453243"/>
            <a:ext cx="184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4B1CBE8-1311-1CC4-FAC3-B0472598A7FF}"/>
              </a:ext>
            </a:extLst>
          </p:cNvPr>
          <p:cNvSpPr txBox="1"/>
          <p:nvPr/>
        </p:nvSpPr>
        <p:spPr>
          <a:xfrm>
            <a:off x="316870" y="325925"/>
            <a:ext cx="6346479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Characterization of SW480 oxaliplatin-resistant mode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dose response curves of SW480 parental (PAR), low dose (LD), mid dose (MD) and high dose (HD) to 48 hours of oxaliplatin treatme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aliplatin 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d change of SW480 LD, MD and HD relative to PAR. Statistical significance was determined using Ordinary one-way ANOVA followed by Dunnett’s multiple comparisons test where a p-value &lt;0.05 is considered significa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x phase contrast images of cell morphologi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well invasion assay in SW480 PAR, LD, MD and HD. Statistical significance was determined using Ordinary one-way ANOVA followed by Dunnett’s multiple comparisons test where a p-value &lt;0.05 is considered significa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well migration assay in SW480 PAR, LD, MD and HD. Statistical significance was determined using Ordinary one-way ANOVA followed by Dunnett’s multiple comparisons test where a p-value &lt;0.05 is considered significa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H&amp;E staining of lung sections for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ntaneous lung metastasis in mice harboring SW480 PAR, LD, MD and HD xenograf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nodule positive area vs total lung area in mice harboring SW480 PAR, LD, MD and HD xenografts (n=5). Statistical significance was determined using Ordinary one-way ANOVA followed by Dunnett’s multiple comparisons test where a p-value &lt;0.05 is considered significa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proliferation rate of HCT116 track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proliferation rate of SW480 track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growth kinetics of SW480 PAR, LD, MD and HD xenografts (n= 5). Statistical significance was determined using Ordinary 2way ANOVA followed by Dunnett’s multiple comparisons test where a p-value &lt; 0.05 is considered significa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images of tumor of SW480 PAR, LD, MD and HD xenograft at day 40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ree representative H&amp;E staining of lung sections from mice harboring SW480 PAR xenografts treated with vehicle or oxaliplatin for spontaneous metastasi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nodule positive area vs total lung area in mice harboring SW480 PAR, LD, MD and HD xenografts (n=4). Statistical significances was determined using two-tailed unpaired t-test.</a:t>
            </a:r>
          </a:p>
        </p:txBody>
      </p:sp>
    </p:spTree>
    <p:extLst>
      <p:ext uri="{BB962C8B-B14F-4D97-AF65-F5344CB8AC3E}">
        <p14:creationId xmlns:p14="http://schemas.microsoft.com/office/powerpoint/2010/main" val="1607774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27</TotalTime>
  <Words>516</Words>
  <Application>Microsoft Macintosh PowerPoint</Application>
  <PresentationFormat>A4 Paper (210x297 mm)</PresentationFormat>
  <Paragraphs>5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W</dc:creator>
  <cp:lastModifiedBy>Wong, Stephen Q.</cp:lastModifiedBy>
  <cp:revision>1044</cp:revision>
  <dcterms:created xsi:type="dcterms:W3CDTF">2020-08-02T08:32:23Z</dcterms:created>
  <dcterms:modified xsi:type="dcterms:W3CDTF">2025-06-24T17:45:00Z</dcterms:modified>
</cp:coreProperties>
</file>